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40" userDrawn="1">
          <p15:clr>
            <a:srgbClr val="A4A3A4"/>
          </p15:clr>
        </p15:guide>
        <p15:guide id="2" pos="4520" userDrawn="1">
          <p15:clr>
            <a:srgbClr val="A4A3A4"/>
          </p15:clr>
        </p15:guide>
        <p15:guide id="4" orient="horz" pos="2205" userDrawn="1">
          <p15:clr>
            <a:srgbClr val="A4A3A4"/>
          </p15:clr>
        </p15:guide>
        <p15:guide id="5" pos="2434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önjes, Ralf Reinhard" initials="TRR" lastIdx="1" clrIdx="0">
    <p:extLst>
      <p:ext uri="{19B8F6BF-5375-455C-9EA6-DF929625EA0E}">
        <p15:presenceInfo xmlns:p15="http://schemas.microsoft.com/office/powerpoint/2012/main" userId="S-1-5-21-439535941-1572631279-2467496428-315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6366" autoAdjust="0"/>
  </p:normalViewPr>
  <p:slideViewPr>
    <p:cSldViewPr snapToGrid="0">
      <p:cViewPr varScale="1">
        <p:scale>
          <a:sx n="111" d="100"/>
          <a:sy n="111" d="100"/>
        </p:scale>
        <p:origin x="456" y="114"/>
      </p:cViewPr>
      <p:guideLst>
        <p:guide orient="horz" pos="2840"/>
        <p:guide pos="4520"/>
        <p:guide orient="horz" pos="2205"/>
        <p:guide pos="243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Formatvorlage des Untertitelmasters durch Klicken bearbeiten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973736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107312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519185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824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88107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37965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08656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47797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217466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31556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628263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EC9A53B-413A-4E49-AF10-ADE6C447F02F}" type="datetimeFigureOut">
              <a:rPr lang="en-US" smtClean="0"/>
              <a:t>7/10/2023</a:t>
            </a:fld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E369D8-6A65-4FC0-A9EB-76D42AF500C6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6800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feld 1"/>
          <p:cNvSpPr txBox="1"/>
          <p:nvPr/>
        </p:nvSpPr>
        <p:spPr>
          <a:xfrm>
            <a:off x="10871838" y="6390452"/>
            <a:ext cx="113588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</a:t>
            </a:r>
            <a:r>
              <a:rPr lang="en-US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endParaRPr 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0" name="Textfeld 39"/>
          <p:cNvSpPr txBox="1"/>
          <p:nvPr/>
        </p:nvSpPr>
        <p:spPr>
          <a:xfrm>
            <a:off x="7997853" y="-2176"/>
            <a:ext cx="48442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4-52</a:t>
            </a:r>
          </a:p>
        </p:txBody>
      </p:sp>
      <p:grpSp>
        <p:nvGrpSpPr>
          <p:cNvPr id="3" name="Gruppieren 2"/>
          <p:cNvGrpSpPr/>
          <p:nvPr/>
        </p:nvGrpSpPr>
        <p:grpSpPr>
          <a:xfrm>
            <a:off x="2674479" y="95697"/>
            <a:ext cx="6843042" cy="6733905"/>
            <a:chOff x="1217483" y="95697"/>
            <a:chExt cx="6843042" cy="6733905"/>
          </a:xfrm>
        </p:grpSpPr>
        <p:pic>
          <p:nvPicPr>
            <p:cNvPr id="21" name="Grafik 20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11508" b="16565"/>
            <a:stretch/>
          </p:blipFill>
          <p:spPr>
            <a:xfrm>
              <a:off x="1536834" y="177648"/>
              <a:ext cx="6288657" cy="2311879"/>
            </a:xfrm>
            <a:prstGeom prst="rect">
              <a:avLst/>
            </a:prstGeom>
          </p:spPr>
        </p:pic>
        <p:cxnSp>
          <p:nvCxnSpPr>
            <p:cNvPr id="22" name="Gerade Verbindung mit Pfeil 21"/>
            <p:cNvCxnSpPr/>
            <p:nvPr/>
          </p:nvCxnSpPr>
          <p:spPr>
            <a:xfrm>
              <a:off x="6782207" y="190947"/>
              <a:ext cx="0" cy="1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Gerade Verbindung mit Pfeil 22"/>
            <p:cNvCxnSpPr/>
            <p:nvPr/>
          </p:nvCxnSpPr>
          <p:spPr>
            <a:xfrm>
              <a:off x="5852040" y="337723"/>
              <a:ext cx="0" cy="1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Gerade Verbindung mit Pfeil 23"/>
            <p:cNvCxnSpPr/>
            <p:nvPr/>
          </p:nvCxnSpPr>
          <p:spPr>
            <a:xfrm flipV="1">
              <a:off x="6216639" y="2086422"/>
              <a:ext cx="0" cy="180000"/>
            </a:xfrm>
            <a:prstGeom prst="straightConnector1">
              <a:avLst/>
            </a:prstGeom>
            <a:ln w="19050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Rechteck 4"/>
            <p:cNvSpPr/>
            <p:nvPr/>
          </p:nvSpPr>
          <p:spPr>
            <a:xfrm>
              <a:off x="1769532" y="370200"/>
              <a:ext cx="5012675" cy="1176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6" name="Gerader Verbinder 5"/>
            <p:cNvCxnSpPr/>
            <p:nvPr/>
          </p:nvCxnSpPr>
          <p:spPr>
            <a:xfrm flipH="1">
              <a:off x="1761912" y="643750"/>
              <a:ext cx="199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Gerader Verbinder 6"/>
            <p:cNvCxnSpPr/>
            <p:nvPr/>
          </p:nvCxnSpPr>
          <p:spPr>
            <a:xfrm flipH="1">
              <a:off x="3748400" y="643750"/>
              <a:ext cx="0" cy="1095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Gerader Verbinder 7"/>
            <p:cNvCxnSpPr/>
            <p:nvPr/>
          </p:nvCxnSpPr>
          <p:spPr>
            <a:xfrm flipH="1">
              <a:off x="1761912" y="753288"/>
              <a:ext cx="199800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hteck 8"/>
            <p:cNvSpPr/>
            <p:nvPr/>
          </p:nvSpPr>
          <p:spPr>
            <a:xfrm>
              <a:off x="2809007" y="779107"/>
              <a:ext cx="1765018" cy="11762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grpSp>
          <p:nvGrpSpPr>
            <p:cNvPr id="10" name="Gruppieren 9"/>
            <p:cNvGrpSpPr/>
            <p:nvPr/>
          </p:nvGrpSpPr>
          <p:grpSpPr>
            <a:xfrm>
              <a:off x="7121297" y="501297"/>
              <a:ext cx="487680" cy="109538"/>
              <a:chOff x="7832993" y="3702684"/>
              <a:chExt cx="487680" cy="109538"/>
            </a:xfrm>
          </p:grpSpPr>
          <p:cxnSp>
            <p:nvCxnSpPr>
              <p:cNvPr id="18" name="Gerader Verbinder 17"/>
              <p:cNvCxnSpPr/>
              <p:nvPr/>
            </p:nvCxnSpPr>
            <p:spPr>
              <a:xfrm>
                <a:off x="7832993" y="3702684"/>
                <a:ext cx="4876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9" name="Gerader Verbinder 18"/>
              <p:cNvCxnSpPr/>
              <p:nvPr/>
            </p:nvCxnSpPr>
            <p:spPr>
              <a:xfrm>
                <a:off x="7840009" y="3702684"/>
                <a:ext cx="0" cy="10953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" name="Gerader Verbinder 19"/>
              <p:cNvCxnSpPr/>
              <p:nvPr/>
            </p:nvCxnSpPr>
            <p:spPr>
              <a:xfrm>
                <a:off x="7832993" y="3812222"/>
                <a:ext cx="48768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1" name="Gruppieren 10"/>
            <p:cNvGrpSpPr/>
            <p:nvPr/>
          </p:nvGrpSpPr>
          <p:grpSpPr>
            <a:xfrm>
              <a:off x="6077725" y="911662"/>
              <a:ext cx="1530000" cy="109538"/>
              <a:chOff x="7128511" y="4702165"/>
              <a:chExt cx="1530000" cy="109538"/>
            </a:xfrm>
          </p:grpSpPr>
          <p:cxnSp>
            <p:nvCxnSpPr>
              <p:cNvPr id="15" name="Gerader Verbinder 14"/>
              <p:cNvCxnSpPr/>
              <p:nvPr/>
            </p:nvCxnSpPr>
            <p:spPr>
              <a:xfrm>
                <a:off x="7128511" y="4702165"/>
                <a:ext cx="153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" name="Gerader Verbinder 15"/>
              <p:cNvCxnSpPr/>
              <p:nvPr/>
            </p:nvCxnSpPr>
            <p:spPr>
              <a:xfrm>
                <a:off x="7135527" y="4702165"/>
                <a:ext cx="0" cy="10953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" name="Gerader Verbinder 16"/>
              <p:cNvCxnSpPr/>
              <p:nvPr/>
            </p:nvCxnSpPr>
            <p:spPr>
              <a:xfrm>
                <a:off x="7128511" y="4811703"/>
                <a:ext cx="1530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12" name="Gerader Verbinder 11"/>
            <p:cNvCxnSpPr/>
            <p:nvPr/>
          </p:nvCxnSpPr>
          <p:spPr>
            <a:xfrm flipH="1">
              <a:off x="1761912" y="1039802"/>
              <a:ext cx="35065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Gerader Verbinder 12"/>
            <p:cNvCxnSpPr/>
            <p:nvPr/>
          </p:nvCxnSpPr>
          <p:spPr>
            <a:xfrm flipH="1">
              <a:off x="5260012" y="1039802"/>
              <a:ext cx="0" cy="109538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Gerader Verbinder 13"/>
            <p:cNvCxnSpPr/>
            <p:nvPr/>
          </p:nvCxnSpPr>
          <p:spPr>
            <a:xfrm flipH="1">
              <a:off x="1761912" y="1149340"/>
              <a:ext cx="3506560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feld 24"/>
            <p:cNvSpPr txBox="1"/>
            <p:nvPr/>
          </p:nvSpPr>
          <p:spPr>
            <a:xfrm>
              <a:off x="1217483" y="9569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</a:t>
              </a:r>
            </a:p>
          </p:txBody>
        </p:sp>
        <p:sp>
          <p:nvSpPr>
            <p:cNvPr id="27" name="Rechteck 26"/>
            <p:cNvSpPr/>
            <p:nvPr/>
          </p:nvSpPr>
          <p:spPr>
            <a:xfrm>
              <a:off x="1536834" y="4027960"/>
              <a:ext cx="6523691" cy="13849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HPTLSRRHLPIRGGKPKRLKIPLSFASIAWFLTLSITSQTNG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IGDSLNSHKPLSLTWLITDSGTGININNTQGEAPLGTWWP</a:t>
              </a:r>
              <a:r>
                <a:rPr lang="de-DE" sz="700" b="1" dirty="0">
                  <a:solidFill>
                    <a:schemeClr val="accent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YPYDVPDYA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DLYVCLRSVIP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LTSPPDILHAHGFYVCPGPPNNGKH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GNPRDFFCKQWNCVTSNDGYWKWPTSQQDRVSFSYV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TYTSSGQFNYLTWIRTGSPKCSP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DLDYLKISFTEKGKQENILKWVNGMSWGMVYYGGSGKQPGSILTIRLKINQLE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MAIGPNTVLTGQRPPTQGPGPSSNITSGSDPTESNSTTKM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KLFSLIQGAFQALNSTTPEATSSCWLCLALGPPYYEGMARRGKFNVTKEHRDQCTWGSQNKLTLTEVSGKGTCIGKVPPSHQHLCNHTEAFNQTSESQYLVPGYDRWWACNTGLTPCVSTLVFNQTKDFCIMVQIVPRVYYYPEKAILDEYDYRNHRQKREPISLTLAVMLGLGVAAGVGTGTAALVTGPQQLETGLSNLHRIVTEDLQALEKSVSNLEESLTSLSEVVLQNRRGLDLLFLKEGGLCVALKEECCFYVDHSGAIRDSMNKLRERLEKRRREKETTQGWFEGWFNRSPWLATLLSALTGPLIVLLLLLTVGPCIINKLIAFIRERISAVQIMVLRQQYQSPSSREAGR</a:t>
              </a:r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1217483" y="3898570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</a:t>
              </a:r>
            </a:p>
          </p:txBody>
        </p:sp>
        <p:sp>
          <p:nvSpPr>
            <p:cNvPr id="30" name="Rechteck 29"/>
            <p:cNvSpPr/>
            <p:nvPr/>
          </p:nvSpPr>
          <p:spPr>
            <a:xfrm>
              <a:off x="1536834" y="2611314"/>
              <a:ext cx="6523691" cy="13849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HPTLSRRHLPIRGGKPKRLKIPLSFASIAWFLTLSITSQTNG</a:t>
              </a:r>
              <a:r>
                <a:rPr lang="de-DE" sz="700" b="1" dirty="0">
                  <a:solidFill>
                    <a:schemeClr val="accent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YPYDVPDYA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IGDSLNSHKPLSLTWLITDSGTGININNTQGEAPLGTWWPDLYVCLRSVIP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LTSPPDILHAHGFYVCPGPPNNGKH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GNPRDFFCKQWNCVTSNDGYWKWPTSQQDRVSFSYV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TYTSSGQFNYLTWIRTGSPKCSP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DLDYLKISFTEKGKQENILKWVNGMSWGMVYYGGSGKQPGSILTIRLKINQLE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MAIGPNTVLTGQRPPTQGPGPSSNITSGSDPTESNSTTKM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KLFSLIQGAFQALNSTTPEATSSCWLCLALGPPYYEGMARRGKFNVTKEHRDQCTWGSQNKLTLTEVSGKGTCIGKVPPSHQHLCNHTEAFNQTSESQYLVPGYDRWWACNTGLTPCVSTLVFNQTKDFCIMVQIVPRVYYYPEKAILDEYDYRNHRQKREPISLTLAVMLGLGVAAGVGTGTAALVTGPQQLETGLSNLHRIVTEDLQALEKSVSNLEESLTSLSEVVLQNRRGLDLLFLKEGGLCVALKEECCFYVDHSGAIRDSMNKLRERLEKRRREKETTQGWFEGWFNRSPWLATLLSALTGPLIVLLLLLTVGPCIINKLIAFIRERISAVQIMVLRQQYQSPSSREAGR</a:t>
              </a:r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1217483" y="2481924"/>
              <a:ext cx="3048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</a:t>
              </a:r>
            </a:p>
          </p:txBody>
        </p:sp>
        <p:sp>
          <p:nvSpPr>
            <p:cNvPr id="33" name="Rechteck 32"/>
            <p:cNvSpPr/>
            <p:nvPr/>
          </p:nvSpPr>
          <p:spPr>
            <a:xfrm>
              <a:off x="1536834" y="5444607"/>
              <a:ext cx="6523691" cy="1384995"/>
            </a:xfrm>
            <a:prstGeom prst="rect">
              <a:avLst/>
            </a:prstGeom>
            <a:ln>
              <a:solidFill>
                <a:schemeClr val="tx1"/>
              </a:solidFill>
            </a:ln>
          </p:spPr>
          <p:txBody>
            <a:bodyPr wrap="square">
              <a:spAutoFit/>
            </a:bodyPr>
            <a:lstStyle/>
            <a:p>
              <a:pPr>
                <a:lnSpc>
                  <a:spcPct val="200000"/>
                </a:lnSpc>
                <a:spcAft>
                  <a:spcPts val="800"/>
                </a:spcAft>
              </a:pP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HPTLSRRHLPIRGGKPKRLKIPLSFASIAWFLTLSITSQTNG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MRIGDSLNSHKPLSLTWLITDSGTGININNTQGEAPLGTWWPDLYVCLRSVIP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LTSPPDILHAHGFYVCPGPPNNGKH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CGNPRDFFCKQWNCVTSNDGYWKWPTSQQDRVSFSYV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NTYTSSGQFNYLTWIRTGSPKCSP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SDLDYLKISFTEKGKQENILKWVNGMSWGMVYYGGSGKQPGSILTIRLKINQLE</a:t>
              </a:r>
              <a:r>
                <a:rPr lang="de-DE" sz="700" b="1" u="sng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PPMAIGPNTVLTGQRPPTQGPGPSSNITSGSDPTESNSTTKM</a:t>
              </a:r>
              <a:r>
                <a:rPr lang="de-DE" sz="700" dirty="0"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GAKLFSLIQGAFQALNSTTPEATSSCWLCLALGPPYYEGMARRGKFNVTKEHRDQCTWGSQNKLTLTEVSGKGTCIGKVPPSHQHLCNHTEAFNQTSESQYLVPGYDRWWACNTGLTPCVSTLVFNQTKDFCIMVQIVPRVYYYPEKAILDEYDYRNHRQKREPISLTLAVMLGLGVAAGVGTGTAALVTGPQQLETGLSNLHRIVTEDLQALEKSVSNLEESLTSLSEVVLQNRRGLDLLFLKEGGLCVALKEECCFYVDHSGAIRDSMNKLRERLEKRRREKETTQGWFEGWFNRSPWLATLLSALTGPLIVLLLLLTVGPCIINKLIAFIRERISAVQIMVLRQQYQSPSSREAGR</a:t>
              </a:r>
              <a:r>
                <a:rPr lang="de-DE" sz="700" b="1" dirty="0">
                  <a:solidFill>
                    <a:schemeClr val="accent1"/>
                  </a:solidFill>
                  <a:latin typeface="Times New Roman" panose="02020603050405020304" pitchFamily="18" charset="0"/>
                  <a:ea typeface="Calibri" panose="020F0502020204030204" pitchFamily="34" charset="0"/>
                  <a:cs typeface="Times New Roman" panose="02020603050405020304" pitchFamily="18" charset="0"/>
                </a:rPr>
                <a:t>YPYDVPDYA</a:t>
              </a:r>
              <a:endParaRPr lang="de-DE" sz="7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1217483" y="5315217"/>
              <a:ext cx="31451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</a:t>
              </a: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5595088" y="127702"/>
              <a:ext cx="48442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86-94</a:t>
              </a: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5921260" y="2209742"/>
              <a:ext cx="612668" cy="246221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0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639-647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1051263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</Words>
  <Application>Microsoft Office PowerPoint</Application>
  <PresentationFormat>Breitbild</PresentationFormat>
  <Paragraphs>1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Company>Paul-Ehrlich-Institu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Flecks, Merle</dc:creator>
  <cp:lastModifiedBy>Flecks, Merle</cp:lastModifiedBy>
  <cp:revision>342</cp:revision>
  <dcterms:created xsi:type="dcterms:W3CDTF">2023-01-11T10:46:46Z</dcterms:created>
  <dcterms:modified xsi:type="dcterms:W3CDTF">2023-07-10T16:49:36Z</dcterms:modified>
</cp:coreProperties>
</file>